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83" r:id="rId2"/>
  </p:sldIdLst>
  <p:sldSz cx="9144000" cy="6858000" type="screen4x3"/>
  <p:notesSz cx="6797675" cy="9928225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pitchFamily="-123" charset="0"/>
        <a:ea typeface="ＭＳ Ｐゴシック" pitchFamily="-123" charset="-128"/>
        <a:cs typeface="ＭＳ Ｐゴシック" pitchFamily="-123" charset="-128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76" d="100"/>
          <a:sy n="76" d="100"/>
        </p:scale>
        <p:origin x="342" y="8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C4A77B-6283-4730-BC35-91550FBFC96C}" type="datetimeFigureOut">
              <a:rPr lang="en-US" smtClean="0"/>
              <a:t>1/29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AC3CCF-6B98-4EF6-BB44-125CA4232D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640861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FC37AB-B8FC-470D-B252-BE2130B17F5D}" type="datetimeFigureOut">
              <a:rPr lang="en-US" smtClean="0"/>
              <a:t>1/29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65225" y="1241425"/>
            <a:ext cx="44672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450" y="4778375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847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9B9785C-D423-45BB-A6D4-2A9574A32B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57148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5C8761-A422-401C-934F-DBB434D69F50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496F16-8245-4CC6-B49A-CA3E3A46380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71CE55-6C7D-4145-8460-9AD6D3679E1A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F36B242-A357-4C6A-8CF1-B3F5C74775C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93D18F-C672-499C-8F87-19232F6E6709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AC726E-0186-4A77-97B7-F45801C04DE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F80F586-8630-49BB-8DF2-F3F42D033278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BD1C440-DEBD-496C-BFDD-5CC6DA0A712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48D108B-CC42-4EC1-97B6-602A037E04CE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4B7E995-D04A-458D-A2B8-EB0DD53F0C2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E17BCEF-2346-4706-A4EB-A6E714A2D318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1F4B1D9-8E9A-4794-8D91-0428B304400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C283F5-7672-4CA6-B4C5-02C42780DFD5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6EE5E1-2B6E-4C7F-8984-CAA8CECAAF4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1667B2-222A-4613-B5FD-AFF51622079D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3345384-5FD2-4804-B082-19F88AF9988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08AFD0A-1B8D-4B43-B27D-834DEA511307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CF406C-30C0-4708-A53A-6DA1084107D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16F876-A80F-4237-96C7-029811984924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3B0E952-FD0B-4713-8FC1-C76196ECD0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3996F7-9BFF-4EF4-97A2-72E097AE9F9C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FBF5A2-3AF0-401F-AAAE-86AFA84729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DE5559E7-C590-4B48-8F91-8FF7791530FB}" type="datetimeFigureOut">
              <a:rPr lang="en-US"/>
              <a:pPr>
                <a:defRPr/>
              </a:pPr>
              <a:t>1/29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8AC322C4-652A-466C-B9B6-4BC3DA09997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pitchFamily="-123" charset="-128"/>
          <a:cs typeface="ＭＳ Ｐゴシック" pitchFamily="-123" charset="-128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-123" charset="0"/>
          <a:ea typeface="ＭＳ Ｐゴシック" pitchFamily="-123" charset="-128"/>
          <a:cs typeface="ＭＳ Ｐゴシック" pitchFamily="-123" charset="-128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pitchFamily="-123" charset="0"/>
        <a:buChar char="•"/>
        <a:defRPr sz="3200" kern="1200">
          <a:solidFill>
            <a:schemeClr val="tx1"/>
          </a:solidFill>
          <a:latin typeface="+mn-lt"/>
          <a:ea typeface="ＭＳ Ｐゴシック" pitchFamily="-123" charset="-128"/>
          <a:cs typeface="ＭＳ Ｐゴシック" pitchFamily="-123" charset="-128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pitchFamily="-123" charset="0"/>
        <a:buChar char="–"/>
        <a:defRPr sz="28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•"/>
        <a:defRPr sz="24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–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pitchFamily="-123" charset="0"/>
        <a:buChar char="»"/>
        <a:defRPr sz="2000" kern="1200">
          <a:solidFill>
            <a:schemeClr val="tx1"/>
          </a:solidFill>
          <a:latin typeface="+mn-lt"/>
          <a:ea typeface="ＭＳ Ｐゴシック" pitchFamily="-123" charset="-128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26">
            <a:extLst>
              <a:ext uri="{FF2B5EF4-FFF2-40B4-BE49-F238E27FC236}">
                <a16:creationId xmlns:a16="http://schemas.microsoft.com/office/drawing/2014/main" id="{E8615BF4-3826-4DA0-893D-FCEEC9FE79B7}"/>
              </a:ext>
            </a:extLst>
          </p:cNvPr>
          <p:cNvGrpSpPr/>
          <p:nvPr/>
        </p:nvGrpSpPr>
        <p:grpSpPr>
          <a:xfrm>
            <a:off x="2828022" y="764704"/>
            <a:ext cx="4856459" cy="2160240"/>
            <a:chOff x="687268" y="510997"/>
            <a:chExt cx="7727478" cy="2674571"/>
          </a:xfrm>
        </p:grpSpPr>
        <p:pic>
          <p:nvPicPr>
            <p:cNvPr id="3" name="Picture 27">
              <a:extLst>
                <a:ext uri="{FF2B5EF4-FFF2-40B4-BE49-F238E27FC236}">
                  <a16:creationId xmlns:a16="http://schemas.microsoft.com/office/drawing/2014/main" id="{2C09C3D2-3BB6-4CEC-8117-DCEED49C903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r="15127"/>
            <a:stretch/>
          </p:blipFill>
          <p:spPr>
            <a:xfrm>
              <a:off x="687268" y="510997"/>
              <a:ext cx="7727478" cy="2457143"/>
            </a:xfrm>
            <a:prstGeom prst="rect">
              <a:avLst/>
            </a:prstGeom>
          </p:spPr>
        </p:pic>
        <p:pic>
          <p:nvPicPr>
            <p:cNvPr id="4" name="Picture 28">
              <a:extLst>
                <a:ext uri="{FF2B5EF4-FFF2-40B4-BE49-F238E27FC236}">
                  <a16:creationId xmlns:a16="http://schemas.microsoft.com/office/drawing/2014/main" id="{2D128C3F-EC42-4DA1-B46A-1B9478D88A9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16200000">
              <a:off x="6141861" y="1990463"/>
              <a:ext cx="209993" cy="2180218"/>
            </a:xfrm>
            <a:prstGeom prst="rect">
              <a:avLst/>
            </a:prstGeom>
          </p:spPr>
        </p:pic>
      </p:grpSp>
      <p:graphicFrame>
        <p:nvGraphicFramePr>
          <p:cNvPr id="5" name="Table 29">
            <a:extLst>
              <a:ext uri="{FF2B5EF4-FFF2-40B4-BE49-F238E27FC236}">
                <a16:creationId xmlns:a16="http://schemas.microsoft.com/office/drawing/2014/main" id="{DD9B1EC4-79E6-4663-B350-4FB1CA9A9E2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75156292"/>
              </p:ext>
            </p:extLst>
          </p:nvPr>
        </p:nvGraphicFramePr>
        <p:xfrm>
          <a:off x="2843808" y="3255218"/>
          <a:ext cx="3996897" cy="2237065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740166">
                  <a:extLst>
                    <a:ext uri="{9D8B030D-6E8A-4147-A177-3AD203B41FA5}">
                      <a16:colId xmlns:a16="http://schemas.microsoft.com/office/drawing/2014/main" val="2103086965"/>
                    </a:ext>
                  </a:extLst>
                </a:gridCol>
                <a:gridCol w="3256731">
                  <a:extLst>
                    <a:ext uri="{9D8B030D-6E8A-4147-A177-3AD203B41FA5}">
                      <a16:colId xmlns:a16="http://schemas.microsoft.com/office/drawing/2014/main" val="3633576662"/>
                    </a:ext>
                  </a:extLst>
                </a:gridCol>
              </a:tblGrid>
              <a:tr h="2059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P</a:t>
                      </a:r>
                      <a:r>
                        <a:rPr lang="en-US" sz="1100" b="1" u="none" strike="noStrike" baseline="0" dirty="0">
                          <a:effectLst/>
                        </a:rPr>
                        <a:t> value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b="1" u="none" strike="noStrike" dirty="0">
                          <a:effectLst/>
                        </a:rPr>
                        <a:t>Enriched pathways in eIF4E overexpressing cells</a:t>
                      </a:r>
                      <a:endParaRPr lang="en-US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32539375"/>
                  </a:ext>
                </a:extLst>
              </a:tr>
              <a:tr h="2059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.19E-1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Ribosome - Homo sapiens (human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848002062"/>
                  </a:ext>
                </a:extLst>
              </a:tr>
              <a:tr h="39188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.40E-1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Spliceosome - Homo sapiens (human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258271975"/>
                  </a:ext>
                </a:extLst>
              </a:tr>
              <a:tr h="2059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4.41E-13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RNA transport - Homo sapiens (human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95812464"/>
                  </a:ext>
                </a:extLst>
              </a:tr>
              <a:tr h="2059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1.36E-1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Estrogen signaling pathway - Homo sapiens (human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48607553"/>
                  </a:ext>
                </a:extLst>
              </a:tr>
              <a:tr h="2059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3.83E-1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Cell cycle (G2/M)- Homo sapiens (human)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072404953"/>
                  </a:ext>
                </a:extLst>
              </a:tr>
              <a:tr h="2059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9.44E-1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untington disease - Homo sapiens (human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6351035"/>
                  </a:ext>
                </a:extLst>
              </a:tr>
              <a:tr h="2059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9.65E-12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FOXM1 </a:t>
                      </a:r>
                      <a:r>
                        <a:rPr lang="en-US" sz="1100" u="none" strike="noStrike" dirty="0" smtClean="0">
                          <a:effectLst/>
                        </a:rPr>
                        <a:t>signaling</a:t>
                      </a:r>
                      <a:r>
                        <a:rPr lang="en-US" sz="1100" u="none" strike="noStrike" baseline="0" dirty="0" smtClean="0">
                          <a:effectLst/>
                        </a:rPr>
                        <a:t> pathway</a:t>
                      </a:r>
                      <a:r>
                        <a:rPr lang="en-US" sz="1100" u="none" strike="noStrike" dirty="0" smtClean="0">
                          <a:effectLst/>
                        </a:rPr>
                        <a:t> </a:t>
                      </a:r>
                      <a:r>
                        <a:rPr lang="en-US" sz="1100" u="none" strike="noStrike" dirty="0">
                          <a:effectLst/>
                        </a:rPr>
                        <a:t>- Homo sapiens (human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706886889"/>
                  </a:ext>
                </a:extLst>
              </a:tr>
              <a:tr h="2059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2.41E-1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Pathways in cancer - Homo sapiens (human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551563823"/>
                  </a:ext>
                </a:extLst>
              </a:tr>
              <a:tr h="2059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5.82E-1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mRNA surveillance pathway - Homo sapiens (human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112892826"/>
                  </a:ext>
                </a:extLst>
              </a:tr>
              <a:tr h="205990">
                <a:tc>
                  <a:txBody>
                    <a:bodyPr/>
                    <a:lstStyle/>
                    <a:p>
                      <a:pPr algn="ctr" fontAlgn="b"/>
                      <a:r>
                        <a:rPr lang="en-US" sz="1100" u="none" strike="noStrike" dirty="0">
                          <a:effectLst/>
                        </a:rPr>
                        <a:t>6.57E-11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Thermogenesis - Homo sapiens (human)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235364550"/>
                  </a:ext>
                </a:extLst>
              </a:tr>
            </a:tbl>
          </a:graphicData>
        </a:graphic>
      </p:graphicFrame>
      <p:sp>
        <p:nvSpPr>
          <p:cNvPr id="6" name="Rectangle 1">
            <a:extLst>
              <a:ext uri="{FF2B5EF4-FFF2-40B4-BE49-F238E27FC236}">
                <a16:creationId xmlns:a16="http://schemas.microsoft.com/office/drawing/2014/main" id="{BCDF4D5E-6799-401D-8B24-AA3B9B6B837D}"/>
              </a:ext>
            </a:extLst>
          </p:cNvPr>
          <p:cNvSpPr>
            <a:spLocks noChangeArrowheads="1"/>
          </p:cNvSpPr>
          <p:nvPr/>
        </p:nvSpPr>
        <p:spPr bwMode="auto">
          <a:xfrm>
            <a:off x="-36512" y="9522"/>
            <a:ext cx="1657325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prstTxWarp prst="textNoShape">
              <a:avLst/>
            </a:prstTxWarp>
            <a:spAutoFit/>
          </a:bodyPr>
          <a:lstStyle/>
          <a:p>
            <a:r>
              <a:rPr lang="en-GB" altLang="zh-HK" dirty="0"/>
              <a:t>Figure S</a:t>
            </a:r>
            <a:r>
              <a:rPr lang="en-US" altLang="zh-TW" dirty="0"/>
              <a:t>1</a:t>
            </a:r>
            <a:endParaRPr lang="en-GB" altLang="zh-HK" dirty="0"/>
          </a:p>
        </p:txBody>
      </p:sp>
      <p:sp>
        <p:nvSpPr>
          <p:cNvPr id="7" name="TextBox 31">
            <a:extLst>
              <a:ext uri="{FF2B5EF4-FFF2-40B4-BE49-F238E27FC236}">
                <a16:creationId xmlns:a16="http://schemas.microsoft.com/office/drawing/2014/main" id="{9152231E-28BC-494C-9A10-AD29E9903D75}"/>
              </a:ext>
            </a:extLst>
          </p:cNvPr>
          <p:cNvSpPr txBox="1"/>
          <p:nvPr/>
        </p:nvSpPr>
        <p:spPr>
          <a:xfrm>
            <a:off x="2411760" y="323364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a</a:t>
            </a:r>
            <a:endParaRPr lang="en-US" dirty="0"/>
          </a:p>
        </p:txBody>
      </p:sp>
      <p:sp>
        <p:nvSpPr>
          <p:cNvPr id="8" name="TextBox 32">
            <a:extLst>
              <a:ext uri="{FF2B5EF4-FFF2-40B4-BE49-F238E27FC236}">
                <a16:creationId xmlns:a16="http://schemas.microsoft.com/office/drawing/2014/main" id="{416C1460-0F5B-4CF3-B9BE-F975298CB8CD}"/>
              </a:ext>
            </a:extLst>
          </p:cNvPr>
          <p:cNvSpPr txBox="1"/>
          <p:nvPr/>
        </p:nvSpPr>
        <p:spPr>
          <a:xfrm>
            <a:off x="2409800" y="294037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HK" dirty="0"/>
              <a:t>b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229166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405</TotalTime>
  <Words>106</Words>
  <Application>Microsoft Office PowerPoint</Application>
  <PresentationFormat>On-screen Show (4:3)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Theme</vt:lpstr>
      <vt:lpstr>PowerPoint Presentation</vt:lpstr>
    </vt:vector>
  </TitlesOfParts>
  <Company>The University of Hong Kong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 Tsoi Ho</dc:creator>
  <cp:lastModifiedBy>Windows User</cp:lastModifiedBy>
  <cp:revision>97</cp:revision>
  <cp:lastPrinted>2019-05-24T08:26:42Z</cp:lastPrinted>
  <dcterms:created xsi:type="dcterms:W3CDTF">2017-10-03T01:31:32Z</dcterms:created>
  <dcterms:modified xsi:type="dcterms:W3CDTF">2020-01-29T02:57:36Z</dcterms:modified>
</cp:coreProperties>
</file>